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246" y="-13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509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91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261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796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153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63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457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794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4584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348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982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6CF98-0C36-4B24-9646-3BF117A768F3}" type="datetimeFigureOut">
              <a:rPr lang="en-GB" smtClean="0"/>
              <a:t>19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27D8A-CE3C-4D0B-8CAC-1FB28DCFCE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738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496805" y="151672"/>
            <a:ext cx="8056195" cy="1665054"/>
            <a:chOff x="496805" y="151672"/>
            <a:chExt cx="8056195" cy="1665054"/>
          </a:xfrm>
        </p:grpSpPr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0" r="-1394" b="67866"/>
            <a:stretch/>
          </p:blipFill>
          <p:spPr bwMode="auto">
            <a:xfrm>
              <a:off x="496805" y="160726"/>
              <a:ext cx="4206914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34" t="34581" r="-440" b="34166"/>
            <a:stretch/>
          </p:blipFill>
          <p:spPr bwMode="auto">
            <a:xfrm>
              <a:off x="4648996" y="151672"/>
              <a:ext cx="3904004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6" name="Straight Connector 15"/>
            <p:cNvCxnSpPr/>
            <p:nvPr/>
          </p:nvCxnSpPr>
          <p:spPr>
            <a:xfrm>
              <a:off x="4572000" y="1364562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 18"/>
          <p:cNvGrpSpPr/>
          <p:nvPr/>
        </p:nvGrpSpPr>
        <p:grpSpPr>
          <a:xfrm>
            <a:off x="464496" y="1773000"/>
            <a:ext cx="8215360" cy="1664061"/>
            <a:chOff x="464496" y="1773000"/>
            <a:chExt cx="8215360" cy="1664061"/>
          </a:xfrm>
        </p:grpSpPr>
        <p:pic>
          <p:nvPicPr>
            <p:cNvPr id="12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" t="67619" b="323"/>
            <a:stretch/>
          </p:blipFill>
          <p:spPr bwMode="auto">
            <a:xfrm>
              <a:off x="464496" y="1773000"/>
              <a:ext cx="4187092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74" t="3447" r="7072" b="67896"/>
            <a:stretch/>
          </p:blipFill>
          <p:spPr bwMode="auto">
            <a:xfrm>
              <a:off x="4646495" y="1781061"/>
              <a:ext cx="4033361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8" name="Straight Connector 17"/>
            <p:cNvCxnSpPr/>
            <p:nvPr/>
          </p:nvCxnSpPr>
          <p:spPr>
            <a:xfrm>
              <a:off x="4537597" y="3007150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454230" y="3429184"/>
            <a:ext cx="8287615" cy="1668707"/>
            <a:chOff x="454230" y="3429184"/>
            <a:chExt cx="8287615" cy="1668707"/>
          </a:xfrm>
        </p:grpSpPr>
        <p:pic>
          <p:nvPicPr>
            <p:cNvPr id="14" name="Picture 13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4" t="34918" r="6963" b="36181"/>
            <a:stretch/>
          </p:blipFill>
          <p:spPr bwMode="auto">
            <a:xfrm>
              <a:off x="454230" y="3429184"/>
              <a:ext cx="4397285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14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01" t="67197" r="9140" b="4322"/>
            <a:stretch/>
          </p:blipFill>
          <p:spPr bwMode="auto">
            <a:xfrm>
              <a:off x="4767005" y="3441891"/>
              <a:ext cx="3974840" cy="165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0" name="Straight Connector 19"/>
            <p:cNvCxnSpPr/>
            <p:nvPr/>
          </p:nvCxnSpPr>
          <p:spPr>
            <a:xfrm>
              <a:off x="4716404" y="4656535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"/>
          <p:cNvSpPr>
            <a:spLocks noChangeArrowheads="1"/>
          </p:cNvSpPr>
          <p:nvPr/>
        </p:nvSpPr>
        <p:spPr bwMode="auto">
          <a:xfrm>
            <a:off x="611923" y="5229200"/>
            <a:ext cx="8208962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</a:pP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S1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 </a:t>
            </a:r>
            <a:r>
              <a:rPr lang="en-US" altLang="zh-CN" sz="1200" b="1" dirty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Fig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.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Prediction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of frequency of codon usage of IgASE1 when expressed in </a:t>
            </a:r>
            <a:r>
              <a:rPr lang="en-US" altLang="zh-CN" sz="1200" b="1" i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Arabidopsis thaliana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. </a:t>
            </a:r>
            <a:endParaRPr lang="en-US" altLang="zh-CN" sz="1200" b="1" dirty="0" smtClean="0">
              <a:solidFill>
                <a:srgbClr val="000000"/>
              </a:solidFill>
              <a:latin typeface="Times New Roman" pitchFamily="18" charset="0"/>
              <a:sym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</a:pP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The 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columns in red are the mostly rare codons used by </a:t>
            </a:r>
            <a:r>
              <a:rPr lang="en-US" altLang="zh-CN" sz="1200" i="1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Arabidopsis thaliana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rPr>
              <a:t>. The height of the column represents the frequency of codon usage. The 3 CGC codons at positions 10, 20 and 84 are marked in red arrows.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buNone/>
            </a:pPr>
            <a:endParaRPr lang="en-US" altLang="zh-CN" sz="1200" dirty="0" smtClean="0">
              <a:solidFill>
                <a:srgbClr val="000000"/>
              </a:solidFill>
              <a:latin typeface="Times New Roman" pitchFamily="18" charset="0"/>
              <a:sym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549338" y="1163131"/>
            <a:ext cx="45719" cy="2016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3307046" y="1011707"/>
            <a:ext cx="2880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solidFill>
                  <a:srgbClr val="FF0000"/>
                </a:solidFill>
              </a:rPr>
              <a:t>20</a:t>
            </a:r>
            <a:endParaRPr lang="en-GB" sz="600" b="1" dirty="0">
              <a:solidFill>
                <a:srgbClr val="FF0000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428203" y="1163131"/>
            <a:ext cx="45719" cy="2016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428182" y="1010787"/>
            <a:ext cx="2880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solidFill>
                  <a:srgbClr val="FF0000"/>
                </a:solidFill>
              </a:rPr>
              <a:t>20</a:t>
            </a:r>
            <a:endParaRPr lang="en-GB" sz="600" b="1" dirty="0">
              <a:solidFill>
                <a:srgbClr val="FF0000"/>
              </a:solidFill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495122" y="1411172"/>
            <a:ext cx="115193" cy="383573"/>
            <a:chOff x="323528" y="1237533"/>
            <a:chExt cx="115193" cy="383573"/>
          </a:xfrm>
        </p:grpSpPr>
        <p:sp>
          <p:nvSpPr>
            <p:cNvPr id="28" name="TextBox 27"/>
            <p:cNvSpPr txBox="1"/>
            <p:nvPr/>
          </p:nvSpPr>
          <p:spPr>
            <a:xfrm>
              <a:off x="323528" y="1237533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23528" y="1289089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G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3528" y="1344337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402110" y="1474234"/>
              <a:ext cx="0" cy="277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323528" y="1444134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R</a:t>
              </a: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3376982" y="1415406"/>
            <a:ext cx="115193" cy="383573"/>
            <a:chOff x="323528" y="1237533"/>
            <a:chExt cx="115193" cy="383573"/>
          </a:xfrm>
        </p:grpSpPr>
        <p:sp>
          <p:nvSpPr>
            <p:cNvPr id="33" name="TextBox 32"/>
            <p:cNvSpPr txBox="1"/>
            <p:nvPr/>
          </p:nvSpPr>
          <p:spPr>
            <a:xfrm>
              <a:off x="323528" y="1237533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23528" y="1289089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G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23528" y="1344337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402110" y="1474234"/>
              <a:ext cx="0" cy="277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323528" y="1444134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R</a:t>
              </a:r>
            </a:p>
          </p:txBody>
        </p:sp>
      </p:grpSp>
      <p:sp>
        <p:nvSpPr>
          <p:cNvPr id="38" name="Rectangle 37"/>
          <p:cNvSpPr/>
          <p:nvPr/>
        </p:nvSpPr>
        <p:spPr>
          <a:xfrm>
            <a:off x="7210147" y="1156384"/>
            <a:ext cx="45719" cy="2016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7085867" y="1004280"/>
            <a:ext cx="2880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 smtClean="0">
                <a:solidFill>
                  <a:srgbClr val="FF0000"/>
                </a:solidFill>
              </a:rPr>
              <a:t>20</a:t>
            </a:r>
            <a:endParaRPr lang="en-GB" sz="600" b="1" dirty="0">
              <a:solidFill>
                <a:srgbClr val="FF0000"/>
              </a:solidFill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7151130" y="1424329"/>
            <a:ext cx="115193" cy="383573"/>
            <a:chOff x="323528" y="1237533"/>
            <a:chExt cx="115193" cy="383573"/>
          </a:xfrm>
        </p:grpSpPr>
        <p:sp>
          <p:nvSpPr>
            <p:cNvPr id="41" name="TextBox 40"/>
            <p:cNvSpPr txBox="1"/>
            <p:nvPr/>
          </p:nvSpPr>
          <p:spPr>
            <a:xfrm>
              <a:off x="323528" y="1237533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23528" y="1289089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G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23528" y="1344337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 smtClean="0">
                  <a:solidFill>
                    <a:srgbClr val="FF0000"/>
                  </a:solidFill>
                </a:rPr>
                <a:t>C</a:t>
              </a:r>
              <a:endParaRPr lang="en-GB" sz="550" b="1" dirty="0">
                <a:solidFill>
                  <a:srgbClr val="FF0000"/>
                </a:solidFill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402110" y="1474234"/>
              <a:ext cx="0" cy="277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323528" y="1444134"/>
              <a:ext cx="115193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50" b="1" dirty="0">
                  <a:solidFill>
                    <a:srgbClr val="FF0000"/>
                  </a:solidFill>
                </a:rPr>
                <a:t>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093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75</Words>
  <Application>Microsoft Office PowerPoint</Application>
  <PresentationFormat>全屏显示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Theme</vt:lpstr>
      <vt:lpstr>PowerPoint 演示文稿</vt:lpstr>
    </vt:vector>
  </TitlesOfParts>
  <Company>University of Bat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oxiu Qi</dc:creator>
  <cp:lastModifiedBy>baoxiu qi</cp:lastModifiedBy>
  <cp:revision>34</cp:revision>
  <dcterms:created xsi:type="dcterms:W3CDTF">2014-10-28T12:19:56Z</dcterms:created>
  <dcterms:modified xsi:type="dcterms:W3CDTF">2016-06-19T11:46:56Z</dcterms:modified>
</cp:coreProperties>
</file>